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950" userDrawn="1">
          <p15:clr>
            <a:srgbClr val="A4A3A4"/>
          </p15:clr>
        </p15:guide>
        <p15:guide id="2" pos="293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972" autoAdjust="0"/>
    <p:restoredTop sz="94660"/>
  </p:normalViewPr>
  <p:slideViewPr>
    <p:cSldViewPr snapToGrid="0" showGuides="1">
      <p:cViewPr varScale="1">
        <p:scale>
          <a:sx n="75" d="100"/>
          <a:sy n="75" d="100"/>
        </p:scale>
        <p:origin x="1200" y="72"/>
      </p:cViewPr>
      <p:guideLst>
        <p:guide orient="horz" pos="1950"/>
        <p:guide pos="293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3215C-749E-48F5-B50F-17BFCCF9E872}" type="datetimeFigureOut">
              <a:rPr lang="en-US" smtClean="0"/>
              <a:t>7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E071C-B76D-4329-9E8E-752492D791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19262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3215C-749E-48F5-B50F-17BFCCF9E872}" type="datetimeFigureOut">
              <a:rPr lang="en-US" smtClean="0"/>
              <a:t>7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E071C-B76D-4329-9E8E-752492D791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2947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3215C-749E-48F5-B50F-17BFCCF9E872}" type="datetimeFigureOut">
              <a:rPr lang="en-US" smtClean="0"/>
              <a:t>7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E071C-B76D-4329-9E8E-752492D791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03173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3215C-749E-48F5-B50F-17BFCCF9E872}" type="datetimeFigureOut">
              <a:rPr lang="en-US" smtClean="0"/>
              <a:t>7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E071C-B76D-4329-9E8E-752492D791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53053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3215C-749E-48F5-B50F-17BFCCF9E872}" type="datetimeFigureOut">
              <a:rPr lang="en-US" smtClean="0"/>
              <a:t>7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E071C-B76D-4329-9E8E-752492D791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41137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3215C-749E-48F5-B50F-17BFCCF9E872}" type="datetimeFigureOut">
              <a:rPr lang="en-US" smtClean="0"/>
              <a:t>7/2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E071C-B76D-4329-9E8E-752492D791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72931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3215C-749E-48F5-B50F-17BFCCF9E872}" type="datetimeFigureOut">
              <a:rPr lang="en-US" smtClean="0"/>
              <a:t>7/26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E071C-B76D-4329-9E8E-752492D791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15547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3215C-749E-48F5-B50F-17BFCCF9E872}" type="datetimeFigureOut">
              <a:rPr lang="en-US" smtClean="0"/>
              <a:t>7/26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E071C-B76D-4329-9E8E-752492D791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96518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3215C-749E-48F5-B50F-17BFCCF9E872}" type="datetimeFigureOut">
              <a:rPr lang="en-US" smtClean="0"/>
              <a:t>7/26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E071C-B76D-4329-9E8E-752492D791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25420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3215C-749E-48F5-B50F-17BFCCF9E872}" type="datetimeFigureOut">
              <a:rPr lang="en-US" smtClean="0"/>
              <a:t>7/2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E071C-B76D-4329-9E8E-752492D791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42848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3215C-749E-48F5-B50F-17BFCCF9E872}" type="datetimeFigureOut">
              <a:rPr lang="en-US" smtClean="0"/>
              <a:t>7/2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E071C-B76D-4329-9E8E-752492D791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74660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A3215C-749E-48F5-B50F-17BFCCF9E872}" type="datetimeFigureOut">
              <a:rPr lang="en-US" smtClean="0"/>
              <a:t>7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6E071C-B76D-4329-9E8E-752492D791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86110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18" Type="http://schemas.openxmlformats.org/officeDocument/2006/relationships/image" Target="../media/image17.jpeg"/><Relationship Id="rId3" Type="http://schemas.openxmlformats.org/officeDocument/2006/relationships/image" Target="../media/image2.jpeg"/><Relationship Id="rId21" Type="http://schemas.openxmlformats.org/officeDocument/2006/relationships/image" Target="../media/image20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17" Type="http://schemas.openxmlformats.org/officeDocument/2006/relationships/image" Target="../media/image16.jpeg"/><Relationship Id="rId2" Type="http://schemas.openxmlformats.org/officeDocument/2006/relationships/image" Target="../media/image1.jpeg"/><Relationship Id="rId16" Type="http://schemas.openxmlformats.org/officeDocument/2006/relationships/image" Target="../media/image15.jpeg"/><Relationship Id="rId20" Type="http://schemas.openxmlformats.org/officeDocument/2006/relationships/image" Target="../media/image19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5" Type="http://schemas.openxmlformats.org/officeDocument/2006/relationships/image" Target="../media/image14.jpeg"/><Relationship Id="rId10" Type="http://schemas.openxmlformats.org/officeDocument/2006/relationships/image" Target="../media/image9.jpeg"/><Relationship Id="rId19" Type="http://schemas.openxmlformats.org/officeDocument/2006/relationships/image" Target="../media/image18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312912" y="785014"/>
            <a:ext cx="10829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/>
              <a:t>1× MES buffer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969903" y="785014"/>
            <a:ext cx="5739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/>
              <a:t>24 hrs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4368202" y="785014"/>
            <a:ext cx="5739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/>
              <a:t>48 hrs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5717088" y="785014"/>
            <a:ext cx="5739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/>
              <a:t>72 hrs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84172" y="1642842"/>
            <a:ext cx="6590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/>
              <a:t>Control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42825" y="2931699"/>
            <a:ext cx="89710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A" sz="1200" dirty="0"/>
              <a:t>Low R:FR</a:t>
            </a:r>
          </a:p>
          <a:p>
            <a:pPr algn="ctr"/>
            <a:r>
              <a:rPr lang="en-CA" sz="1200" dirty="0"/>
              <a:t>(biological)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69410" y="4158760"/>
            <a:ext cx="1066960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A" sz="1200" dirty="0"/>
              <a:t>Low R:FR</a:t>
            </a:r>
          </a:p>
          <a:p>
            <a:pPr algn="ctr"/>
            <a:r>
              <a:rPr lang="en-CA" sz="1200" dirty="0"/>
              <a:t>(biological)</a:t>
            </a:r>
          </a:p>
          <a:p>
            <a:pPr algn="ctr"/>
            <a:r>
              <a:rPr lang="en-CA" sz="1200" dirty="0"/>
              <a:t>transferred to</a:t>
            </a:r>
          </a:p>
          <a:p>
            <a:pPr algn="ctr"/>
            <a:r>
              <a:rPr lang="en-CA" sz="1200" dirty="0"/>
              <a:t>control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37569" y="5741897"/>
            <a:ext cx="80502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A" sz="1200" dirty="0"/>
              <a:t>Low R:FR</a:t>
            </a:r>
          </a:p>
          <a:p>
            <a:pPr algn="ctr"/>
            <a:r>
              <a:rPr lang="en-CA" sz="1200" dirty="0"/>
              <a:t>(artificial)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69256" y="6974124"/>
            <a:ext cx="1066960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A" sz="1200" dirty="0"/>
              <a:t>Low R:FR</a:t>
            </a:r>
          </a:p>
          <a:p>
            <a:pPr algn="ctr"/>
            <a:r>
              <a:rPr lang="en-CA" sz="1200" dirty="0"/>
              <a:t>(artificial)</a:t>
            </a:r>
          </a:p>
          <a:p>
            <a:pPr algn="ctr"/>
            <a:r>
              <a:rPr lang="en-CA" sz="1200" dirty="0"/>
              <a:t>transferred to</a:t>
            </a:r>
          </a:p>
          <a:p>
            <a:pPr algn="ctr"/>
            <a:r>
              <a:rPr lang="en-CA" sz="1200" dirty="0"/>
              <a:t>control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B84598DC-F699-7E40-8805-9825DDDF306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2598" y="1096000"/>
            <a:ext cx="1404000" cy="14040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24CB1CC8-4BC2-D335-0D92-B7A471CF51B7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43659" y="1096212"/>
            <a:ext cx="1404000" cy="140400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6A248694-E6D9-C6E1-1FF5-851068567C91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3936280" y="1095745"/>
            <a:ext cx="1404000" cy="140400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CF396296-0315-6FDD-08C9-0D7A226DADDA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31333" y="1095745"/>
            <a:ext cx="1404000" cy="140400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4B8608C4-015C-031D-185A-5A5324838048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200" y="2488262"/>
            <a:ext cx="1404000" cy="140400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89C60CFE-F016-43CC-55B9-EED2ECF5573A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45200" y="2489898"/>
            <a:ext cx="1404000" cy="140400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C3E60366-83C9-50CB-93AD-E1242587AFCC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3936843" y="2489898"/>
            <a:ext cx="1404000" cy="1404000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B92D4D4A-4220-EB6E-3C83-2CA76E09E366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29406" y="2489898"/>
            <a:ext cx="1404000" cy="1404000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8D9962E3-6413-53A3-BC83-20A5E0DE84B5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200" y="3881402"/>
            <a:ext cx="1404000" cy="1404000"/>
          </a:xfrm>
          <a:prstGeom prst="rect">
            <a:avLst/>
          </a:prstGeom>
        </p:spPr>
      </p:pic>
      <p:pic>
        <p:nvPicPr>
          <p:cNvPr id="21" name="Content Placeholder 18">
            <a:extLst>
              <a:ext uri="{FF2B5EF4-FFF2-40B4-BE49-F238E27FC236}">
                <a16:creationId xmlns:a16="http://schemas.microsoft.com/office/drawing/2014/main" id="{2FA02578-81E6-E045-7339-576D0A0947BD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2545200" y="3881541"/>
            <a:ext cx="1404000" cy="1404000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C25E0331-E4C5-CC02-32F1-EABF20097D68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3936843" y="3881541"/>
            <a:ext cx="1404000" cy="1404000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8D5A562E-E52F-9BB7-5A4D-6D487E58C9C7}"/>
              </a:ext>
            </a:extLst>
          </p:cNvPr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5330043" y="3881541"/>
            <a:ext cx="1404000" cy="1404000"/>
          </a:xfrm>
          <a:prstGeom prst="rect">
            <a:avLst/>
          </a:prstGeom>
        </p:spPr>
      </p:pic>
      <p:pic>
        <p:nvPicPr>
          <p:cNvPr id="24" name="Picture 2" descr="Image preview">
            <a:extLst>
              <a:ext uri="{FF2B5EF4-FFF2-40B4-BE49-F238E27FC236}">
                <a16:creationId xmlns:a16="http://schemas.microsoft.com/office/drawing/2014/main" id="{D71B650A-6FD3-13F8-57BB-0BC39B5AA3A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41200" y="5280374"/>
            <a:ext cx="1404000" cy="1404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07898D0E-2F27-5993-440B-8E1BE699D468}"/>
              </a:ext>
            </a:extLst>
          </p:cNvPr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2543818" y="5281941"/>
            <a:ext cx="1404000" cy="1404000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574E1704-D028-00DD-67B2-EE4018D0142F}"/>
              </a:ext>
            </a:extLst>
          </p:cNvPr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3936843" y="5281941"/>
            <a:ext cx="1404000" cy="1404000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D45DA944-5E0E-04FC-AF97-5EE2DBD43FD9}"/>
              </a:ext>
            </a:extLst>
          </p:cNvPr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5330043" y="5281941"/>
            <a:ext cx="1404000" cy="1404000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DF9B56A0-FE9D-886E-DDD4-B97105C81EF0}"/>
              </a:ext>
            </a:extLst>
          </p:cNvPr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200" y="6682340"/>
            <a:ext cx="1404000" cy="1404000"/>
          </a:xfrm>
          <a:prstGeom prst="rect">
            <a:avLst/>
          </a:prstGeom>
        </p:spPr>
      </p:pic>
      <p:pic>
        <p:nvPicPr>
          <p:cNvPr id="29" name="Content Placeholder 18">
            <a:extLst>
              <a:ext uri="{FF2B5EF4-FFF2-40B4-BE49-F238E27FC236}">
                <a16:creationId xmlns:a16="http://schemas.microsoft.com/office/drawing/2014/main" id="{3C36B6ED-DF2D-2EF6-1A93-4A0248883CA0}"/>
              </a:ext>
            </a:extLst>
          </p:cNvPr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2545200" y="6682341"/>
            <a:ext cx="1404000" cy="1404000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ED395D4D-2A6A-4C71-F8F7-BA19386196AF}"/>
              </a:ext>
            </a:extLst>
          </p:cNvPr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3936843" y="6682341"/>
            <a:ext cx="1404000" cy="1404000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C7E5651E-0086-C0D7-7E3A-5C41896194DC}"/>
              </a:ext>
            </a:extLst>
          </p:cNvPr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5330043" y="6682341"/>
            <a:ext cx="1404000" cy="1404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3371332-2A8A-F48F-4B3E-62442ACE3AAE}"/>
              </a:ext>
            </a:extLst>
          </p:cNvPr>
          <p:cNvSpPr txBox="1"/>
          <p:nvPr/>
        </p:nvSpPr>
        <p:spPr>
          <a:xfrm>
            <a:off x="1117600" y="105375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A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1DD8B20-ABEE-093A-B2D1-A024B8371800}"/>
              </a:ext>
            </a:extLst>
          </p:cNvPr>
          <p:cNvSpPr txBox="1"/>
          <p:nvPr/>
        </p:nvSpPr>
        <p:spPr>
          <a:xfrm>
            <a:off x="2527300" y="105375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B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71596898-E4D0-7E9C-B5FD-9931B78D0AC1}"/>
              </a:ext>
            </a:extLst>
          </p:cNvPr>
          <p:cNvSpPr txBox="1"/>
          <p:nvPr/>
        </p:nvSpPr>
        <p:spPr>
          <a:xfrm>
            <a:off x="3911643" y="105375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C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B737F86C-8D82-204F-CB34-C47B84A5726D}"/>
              </a:ext>
            </a:extLst>
          </p:cNvPr>
          <p:cNvSpPr txBox="1"/>
          <p:nvPr/>
        </p:nvSpPr>
        <p:spPr>
          <a:xfrm>
            <a:off x="5321643" y="1053757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D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044D3231-B0D0-746E-9BA3-B162E1076E10}"/>
              </a:ext>
            </a:extLst>
          </p:cNvPr>
          <p:cNvSpPr txBox="1"/>
          <p:nvPr/>
        </p:nvSpPr>
        <p:spPr>
          <a:xfrm>
            <a:off x="1117600" y="2449557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E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2366DA32-563C-A9CA-FD1C-234DA1B6FD8B}"/>
              </a:ext>
            </a:extLst>
          </p:cNvPr>
          <p:cNvSpPr txBox="1"/>
          <p:nvPr/>
        </p:nvSpPr>
        <p:spPr>
          <a:xfrm>
            <a:off x="1117600" y="3835400"/>
            <a:ext cx="2423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I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5016F59D-54EA-94BC-C916-5BC8BC11F619}"/>
              </a:ext>
            </a:extLst>
          </p:cNvPr>
          <p:cNvSpPr txBox="1"/>
          <p:nvPr/>
        </p:nvSpPr>
        <p:spPr>
          <a:xfrm>
            <a:off x="1116000" y="5232400"/>
            <a:ext cx="3818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4C492279-3B5B-666C-24F0-ECDF2913401E}"/>
              </a:ext>
            </a:extLst>
          </p:cNvPr>
          <p:cNvSpPr txBox="1"/>
          <p:nvPr/>
        </p:nvSpPr>
        <p:spPr>
          <a:xfrm>
            <a:off x="1116000" y="6654500"/>
            <a:ext cx="3401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Q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F52160A3-4631-728A-ECD6-D09A27BA451A}"/>
              </a:ext>
            </a:extLst>
          </p:cNvPr>
          <p:cNvSpPr txBox="1"/>
          <p:nvPr/>
        </p:nvSpPr>
        <p:spPr>
          <a:xfrm>
            <a:off x="2527200" y="2450757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F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E5762221-BC62-84FA-9C40-A8A23EBE5814}"/>
              </a:ext>
            </a:extLst>
          </p:cNvPr>
          <p:cNvSpPr txBox="1"/>
          <p:nvPr/>
        </p:nvSpPr>
        <p:spPr>
          <a:xfrm>
            <a:off x="3911943" y="2449557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G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4657287B-765E-9F50-A3E1-632B5F6AA4C9}"/>
              </a:ext>
            </a:extLst>
          </p:cNvPr>
          <p:cNvSpPr txBox="1"/>
          <p:nvPr/>
        </p:nvSpPr>
        <p:spPr>
          <a:xfrm>
            <a:off x="5321643" y="2449557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H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93290F41-D19C-A7E2-6E26-EC800FB47823}"/>
              </a:ext>
            </a:extLst>
          </p:cNvPr>
          <p:cNvSpPr txBox="1"/>
          <p:nvPr/>
        </p:nvSpPr>
        <p:spPr>
          <a:xfrm>
            <a:off x="2592000" y="3834000"/>
            <a:ext cx="2584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J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34F8AC37-4346-C246-A881-EB00F95F7D27}"/>
              </a:ext>
            </a:extLst>
          </p:cNvPr>
          <p:cNvSpPr txBox="1"/>
          <p:nvPr/>
        </p:nvSpPr>
        <p:spPr>
          <a:xfrm>
            <a:off x="3911643" y="3835400"/>
            <a:ext cx="304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K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3C457925-4A77-D69F-C5B2-BE1C37D7D5CB}"/>
              </a:ext>
            </a:extLst>
          </p:cNvPr>
          <p:cNvSpPr txBox="1"/>
          <p:nvPr/>
        </p:nvSpPr>
        <p:spPr>
          <a:xfrm>
            <a:off x="5322843" y="3834000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L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EFF0B667-B536-CBB3-4E4B-8FA69B8E0DB1}"/>
              </a:ext>
            </a:extLst>
          </p:cNvPr>
          <p:cNvSpPr txBox="1"/>
          <p:nvPr/>
        </p:nvSpPr>
        <p:spPr>
          <a:xfrm>
            <a:off x="2592000" y="5231000"/>
            <a:ext cx="3337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N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AA277697-2640-7813-18A9-1E903C52B74E}"/>
              </a:ext>
            </a:extLst>
          </p:cNvPr>
          <p:cNvSpPr txBox="1"/>
          <p:nvPr/>
        </p:nvSpPr>
        <p:spPr>
          <a:xfrm>
            <a:off x="3911643" y="5231000"/>
            <a:ext cx="3337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O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AC656CBF-0DE0-CBCE-520C-283B1F506ABD}"/>
              </a:ext>
            </a:extLst>
          </p:cNvPr>
          <p:cNvSpPr txBox="1"/>
          <p:nvPr/>
        </p:nvSpPr>
        <p:spPr>
          <a:xfrm>
            <a:off x="5322843" y="5231000"/>
            <a:ext cx="3032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P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0E2DDABB-A01E-8D91-850C-3C51A0A56091}"/>
              </a:ext>
            </a:extLst>
          </p:cNvPr>
          <p:cNvSpPr txBox="1"/>
          <p:nvPr/>
        </p:nvSpPr>
        <p:spPr>
          <a:xfrm>
            <a:off x="2592000" y="6654500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R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567ADB7F-BA63-333E-E898-3555D98A4B80}"/>
              </a:ext>
            </a:extLst>
          </p:cNvPr>
          <p:cNvSpPr txBox="1"/>
          <p:nvPr/>
        </p:nvSpPr>
        <p:spPr>
          <a:xfrm>
            <a:off x="3911643" y="6654500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C89C56FD-CCDD-76AC-38BA-454BE45E9679}"/>
              </a:ext>
            </a:extLst>
          </p:cNvPr>
          <p:cNvSpPr txBox="1"/>
          <p:nvPr/>
        </p:nvSpPr>
        <p:spPr>
          <a:xfrm>
            <a:off x="5322843" y="6652800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T</a:t>
            </a:r>
          </a:p>
        </p:txBody>
      </p:sp>
    </p:spTree>
    <p:extLst>
      <p:ext uri="{BB962C8B-B14F-4D97-AF65-F5344CB8AC3E}">
        <p14:creationId xmlns:p14="http://schemas.microsoft.com/office/powerpoint/2010/main" val="13629157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7</TotalTime>
  <Words>65</Words>
  <Application>Microsoft Office PowerPoint</Application>
  <PresentationFormat>On-screen Show (4:3)</PresentationFormat>
  <Paragraphs>3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lliam Kramer</dc:creator>
  <cp:lastModifiedBy>Mitra Serajazari</cp:lastModifiedBy>
  <cp:revision>22</cp:revision>
  <dcterms:created xsi:type="dcterms:W3CDTF">2022-06-07T15:30:06Z</dcterms:created>
  <dcterms:modified xsi:type="dcterms:W3CDTF">2024-07-26T16:44:41Z</dcterms:modified>
</cp:coreProperties>
</file>